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7" d="100"/>
          <a:sy n="87" d="100"/>
        </p:scale>
        <p:origin x="533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75D739F-75A7-4312-B351-776466CCD7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E31CB46-4944-47E5-8C74-2E7B1F4297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D7E07D2-77F9-45E1-BD68-6EC031840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AC38D7-39F6-4BE5-B628-6BD310CDF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DD01E28-DF05-40FC-807C-4315C4C7D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3580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4D0754B-9FE7-465C-945E-1B2D19AD13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2941280-033E-4012-B434-B214883F10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FF293B-4770-4F35-9CDB-BFAB89C3B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369FD04-013C-4014-A979-B30224515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E95B28F-DBFA-458D-81FD-4252D179E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278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145F65C-2E77-4191-BA7B-4842C17DA7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41ACBE7-52C9-4064-A81C-92D7E3DB45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5CEC764-D515-4D08-978C-6367487FD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8AF9ACF-0B7A-4E06-8631-14B5036EA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F31013-CCDB-46B7-B885-B085E21BC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6613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5796915-C4BF-4C42-B16D-2D3FCF854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8A2A020-8A46-47F0-B225-12A75A04DA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2A5228C-B3EE-4313-864D-AF02BD563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972B59E-0B9B-48D7-9786-1A1EFFBC4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E9E9BDD-3DF1-4483-8407-F7EB3D86A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9101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DAEDFF-6AD9-469C-9245-B645A76D69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16BD91-3E2B-4FEC-843B-A4885509E2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DC5D5CA-F854-42B3-8744-2C218B397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37CB628-EC41-44B8-AB5B-1A66C209B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F554BA-C42B-41E0-923C-099DA4239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6545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6351012-C100-48A8-BC62-E2796A33E8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993938C-A5C5-4FAD-B46D-32D617FC11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004CF4B-D475-4860-BCA3-32388A2808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AF15030-7CB7-4741-8CA9-9C5E44AD4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716998D-72CD-4446-9D40-576D83E0F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FE14CE4-1994-4578-BD44-7F15CA0F4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1127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D9EAF2B-2794-4241-A95D-AD73816A3D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8AD56AB-DCD2-4D6C-B405-6681C8718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EF20AE1-73AD-4D64-902D-666B13A42E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C292337-0AB0-4912-8246-F6B090D9A6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1F59C0F-931C-4A77-8DE7-9B82AB82CA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7F8C9A7-4901-4AAC-91F6-BC46AE607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BC13259-06F0-4368-A0CD-B29709F94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27CDE24-489B-4F24-A008-DC50AC433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5802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E1A6A20-3E59-4717-ACA1-A626353523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33B7843C-B1E1-4E46-8F8C-8CEF6AF8E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2BF7E79-C558-45DA-9D67-A853893C1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6B8FFE8-438D-4A12-8D31-2C0EBAD56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0169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755124D-E837-42E5-BFC5-016CEAA21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255D443-ECBF-4F89-AA23-76446981A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289BC50-5495-4429-A3ED-92060F2BB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690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8D83A8-EC25-45E0-B1B7-625FE8596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B75A0B-B398-40CB-9598-11C56B4D0D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FBE1433-3380-4046-9411-5A4131724D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DAB9486-2B40-4DE4-9BB2-B2FA65846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E1649C0-2BBF-4ABD-BB6F-4B417CD7D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315C73F-0032-4441-88A2-B580A3040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6469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9291B0A-7F2E-4722-BED4-9A1432BB35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317CD11-BEE0-43EC-9F10-7B95C20334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0072699-1B7A-49D0-8B56-EA4F1A0EA4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E3C61AF-98D4-4583-BC5D-0F4F1CB1A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937CFF3-9E63-4260-8595-D6D1334FB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C9F91A4-68FC-4112-B56C-EBBB96F67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3877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523D427-2BA0-4C8C-B449-02CB6B7BF9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4A43514-20D4-4A14-B0BA-EC251ECB23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394A65D-1D44-451D-B89E-A76A2C3CB1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DE7699-FF98-4C97-ABB7-1C3E57ACA255}" type="datetimeFigureOut">
              <a:rPr lang="it-IT" smtClean="0"/>
              <a:t>16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F65206B-800A-4AF3-AF3E-1663EF9CDA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D02742-5F29-46FC-8DA8-9FEB589CDA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84A5A1-BD8B-4FA3-A99A-B75C414763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801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 l="62011" t="54847" r="4176" b="5868"/>
          <a:stretch>
            <a:fillRect/>
          </a:stretch>
        </p:blipFill>
        <p:spPr bwMode="auto">
          <a:xfrm>
            <a:off x="2464358" y="938936"/>
            <a:ext cx="6842403" cy="4306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CasellaDiTesto 4"/>
          <p:cNvSpPr txBox="1"/>
          <p:nvPr/>
        </p:nvSpPr>
        <p:spPr>
          <a:xfrm>
            <a:off x="5278589" y="5106379"/>
            <a:ext cx="862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Z-score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B0A9FF03-F72A-4366-9E53-A322EF5354F1}"/>
              </a:ext>
            </a:extLst>
          </p:cNvPr>
          <p:cNvSpPr txBox="1"/>
          <p:nvPr/>
        </p:nvSpPr>
        <p:spPr>
          <a:xfrm>
            <a:off x="-103649" y="5764794"/>
            <a:ext cx="11722683" cy="2788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ts val="1300"/>
              </a:lnSpc>
            </a:pPr>
            <a:r>
              <a:rPr lang="it-IT" sz="18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it-IT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3: </a:t>
            </a:r>
            <a:r>
              <a:rPr lang="en-GB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istribution of Z-score used to assess overall binding ability between 5980 RNAs and 281 RBPs</a:t>
            </a:r>
            <a:endParaRPr lang="it-IT" sz="2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97405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audia Cava</dc:creator>
  <cp:lastModifiedBy>Claudia Cava</cp:lastModifiedBy>
  <cp:revision>1</cp:revision>
  <dcterms:created xsi:type="dcterms:W3CDTF">2021-03-16T12:39:38Z</dcterms:created>
  <dcterms:modified xsi:type="dcterms:W3CDTF">2021-03-16T12:41:17Z</dcterms:modified>
</cp:coreProperties>
</file>